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3" autoAdjust="0"/>
    <p:restoredTop sz="94660"/>
  </p:normalViewPr>
  <p:slideViewPr>
    <p:cSldViewPr snapToGrid="0">
      <p:cViewPr varScale="1">
        <p:scale>
          <a:sx n="85" d="100"/>
          <a:sy n="85" d="100"/>
        </p:scale>
        <p:origin x="108" y="3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9151B9-8862-401B-848F-81A95B7E844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E69F520-A4E0-47E9-90D8-675C00AB8D3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07341C5-514A-4F3B-90EB-6D627E9545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21916-CD71-42E6-B9F4-722C62E49577}" type="datetimeFigureOut">
              <a:rPr lang="en-AU" smtClean="0"/>
              <a:t>13/10/2021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3773BE-0E79-4714-8BD3-063EA1246D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DC22A50-9650-4196-84C7-EC426F0028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BABB4-5D30-4627-A678-1AA2EF3FCF0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403186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6E917A-8A17-4C58-98E0-42C366521C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80A907A-51BC-42A6-9B35-8758E363CFB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05CF2B5-AC72-4C40-9E55-ECAA141951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21916-CD71-42E6-B9F4-722C62E49577}" type="datetimeFigureOut">
              <a:rPr lang="en-AU" smtClean="0"/>
              <a:t>13/10/2021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57B827-99DD-4482-9EEC-A7FF2ADA04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1174AF-B4C5-4D27-86FB-A9D0EBDDF4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BABB4-5D30-4627-A678-1AA2EF3FCF0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906465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8327022-9EF1-47A6-9475-B261D7E2323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45CC263-B253-4D44-B2E9-C1757B2F1D3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B97CAF-1FA8-471B-B473-BAE22CEF0D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21916-CD71-42E6-B9F4-722C62E49577}" type="datetimeFigureOut">
              <a:rPr lang="en-AU" smtClean="0"/>
              <a:t>13/10/2021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968E6C-DBD9-4007-8AB1-98ED84FF22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D29EE9B-1022-4CCC-8A2A-54FD217D6A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BABB4-5D30-4627-A678-1AA2EF3FCF0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932619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179819-40CF-4EF9-924D-28E97E0FB6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C9C83DC-615C-4ADB-A607-3967148C252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82AC8E-C181-4E2F-B943-90D5B9270A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21916-CD71-42E6-B9F4-722C62E49577}" type="datetimeFigureOut">
              <a:rPr lang="en-AU" smtClean="0"/>
              <a:t>13/10/2021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76C5E17-DAC4-4094-ADFA-93AC2DCCD8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BB7FF4F-6A31-423D-9FA8-75F156B9F3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BABB4-5D30-4627-A678-1AA2EF3FCF0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838104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3E9571-3F18-40E7-B60A-EB8EEC07A9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DA1989B-8B72-4A60-ACFF-93268D84EF4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FDEF5B8-EE87-4F1F-A7EE-6484D9F4AC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21916-CD71-42E6-B9F4-722C62E49577}" type="datetimeFigureOut">
              <a:rPr lang="en-AU" smtClean="0"/>
              <a:t>13/10/2021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A82E935-EE4D-4AAA-B1F1-6DBF763C86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6A8994-B2AD-48BB-BEA6-5F3028F394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BABB4-5D30-4627-A678-1AA2EF3FCF0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314182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FF9C60-C148-40A8-9D0A-2D5E3BA26A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8D5ED34-1B5D-4D27-8089-AC574B97BA9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C0E5FDC-6FA4-4012-B9B9-344D56AC9C9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5B3E2A8-73A2-445B-9B05-4702556E9F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21916-CD71-42E6-B9F4-722C62E49577}" type="datetimeFigureOut">
              <a:rPr lang="en-AU" smtClean="0"/>
              <a:t>13/10/2021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6BDB9FA-2152-4336-BC92-D445B01BCD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8E2B54E-7721-407F-B0A6-692E295A83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BABB4-5D30-4627-A678-1AA2EF3FCF0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081822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7CA762-2432-459E-BAF0-A5E280E438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B7A2F90-CAB4-40FD-BA03-12AD639027B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F77E9DC-1837-4FC9-852E-45844433CA4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318AB67-030D-4395-B638-6F93D85EF7A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5B841E1-2023-4CC3-BFC3-AB67A997FF8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10A20EF-E91F-42AC-964A-E4BD4DA2F5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21916-CD71-42E6-B9F4-722C62E49577}" type="datetimeFigureOut">
              <a:rPr lang="en-AU" smtClean="0"/>
              <a:t>13/10/2021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DFA7044-5523-4B04-B79F-ED50D93E99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3BB34E0-D818-4004-987B-D19940ACB6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BABB4-5D30-4627-A678-1AA2EF3FCF0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59324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4E9D11-D16C-49F9-8E2F-61F8F31BD0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8D7148E-ACC7-42D2-8D46-4E1DDE5E34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21916-CD71-42E6-B9F4-722C62E49577}" type="datetimeFigureOut">
              <a:rPr lang="en-AU" smtClean="0"/>
              <a:t>13/10/2021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AE9E805-C592-441C-B31B-BEDE323564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577F3CE-7A61-4C86-9FCC-DE28391B2C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BABB4-5D30-4627-A678-1AA2EF3FCF0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367565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EB37C06-CC77-4631-A1C2-778DFFACD0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21916-CD71-42E6-B9F4-722C62E49577}" type="datetimeFigureOut">
              <a:rPr lang="en-AU" smtClean="0"/>
              <a:t>13/10/2021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0E63AC3-8976-4D46-A3A8-DDE59419C2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A6C7E69-B959-4EF6-AE45-940164BB7C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BABB4-5D30-4627-A678-1AA2EF3FCF0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029773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3C907B-0EC0-4078-A748-0A44E43B01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57ACB6E-FBD9-4D7F-991C-CE33B97E67C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C8A5297-3EF6-4E35-82BA-7CFFED11DD4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0B1FAD2-C6DF-4A10-B002-DE038B0A8B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21916-CD71-42E6-B9F4-722C62E49577}" type="datetimeFigureOut">
              <a:rPr lang="en-AU" smtClean="0"/>
              <a:t>13/10/2021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2DFCD79-5A0B-4EA4-87EC-37E1B06C83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5F9EF8F-DF9C-4336-A009-1AF0CB5DEF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BABB4-5D30-4627-A678-1AA2EF3FCF0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295239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037593-7BF5-44F8-8351-DC487129CD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303FE01-69AE-430E-9A94-A893B40CBA6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76B5E9C-5D6C-4FF8-81DD-490C57F1F3A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4E26561-5B53-4259-900A-751EF7830C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21916-CD71-42E6-B9F4-722C62E49577}" type="datetimeFigureOut">
              <a:rPr lang="en-AU" smtClean="0"/>
              <a:t>13/10/2021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3F6E35F-652C-474C-9530-B21A862ADA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822E843-ECB4-4654-ACF3-15DBEF833D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BABB4-5D30-4627-A678-1AA2EF3FCF0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520126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75AF5AB-2D23-476A-9760-8F5500BD44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BAC69AC-EEA0-479B-AA96-044ACAE87A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4255C6D-4C72-4CAE-94D8-7291B96DD65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621916-CD71-42E6-B9F4-722C62E49577}" type="datetimeFigureOut">
              <a:rPr lang="en-AU" smtClean="0"/>
              <a:t>13/10/2021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425E77-72D8-485E-8D14-722E79174F8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F526E8-B810-4E46-BD37-68901CC401D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3BABB4-5D30-4627-A678-1AA2EF3FCF0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821350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Box 19">
            <a:extLst>
              <a:ext uri="{FF2B5EF4-FFF2-40B4-BE49-F238E27FC236}">
                <a16:creationId xmlns:a16="http://schemas.microsoft.com/office/drawing/2014/main" id="{584EB8B8-E7DD-4F01-940F-980AEA3FE97D}"/>
              </a:ext>
            </a:extLst>
          </p:cNvPr>
          <p:cNvSpPr txBox="1"/>
          <p:nvPr/>
        </p:nvSpPr>
        <p:spPr>
          <a:xfrm>
            <a:off x="1811247" y="5333545"/>
            <a:ext cx="893788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U" b="1" dirty="0"/>
              <a:t>Supplemental Figure 2  A. </a:t>
            </a:r>
            <a:r>
              <a:rPr lang="en-AU" dirty="0"/>
              <a:t>Immunoblot (5 min exposure) showing the 140 kDa eNOS band in control and antibiotic-treated cerebral artery lysates. </a:t>
            </a:r>
            <a:r>
              <a:rPr lang="en-AU" b="1" dirty="0"/>
              <a:t>B.</a:t>
            </a:r>
            <a:r>
              <a:rPr lang="en-AU" dirty="0"/>
              <a:t> Immunoblot (7 min exposure) showing the 140 kDa eNOS-P band in control and antibiotic-treated cerebral artery lysates. </a:t>
            </a:r>
          </a:p>
          <a:p>
            <a:pPr algn="just"/>
            <a:r>
              <a:rPr lang="en-AU" dirty="0"/>
              <a:t> </a:t>
            </a:r>
          </a:p>
        </p:txBody>
      </p:sp>
      <p:pic>
        <p:nvPicPr>
          <p:cNvPr id="22" name="Picture 21">
            <a:extLst>
              <a:ext uri="{FF2B5EF4-FFF2-40B4-BE49-F238E27FC236}">
                <a16:creationId xmlns:a16="http://schemas.microsoft.com/office/drawing/2014/main" id="{3B5B5525-E913-4FB8-A497-B3609E5FF94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6754" t="34786" r="37302" b="41002"/>
          <a:stretch/>
        </p:blipFill>
        <p:spPr>
          <a:xfrm>
            <a:off x="3463939" y="1050294"/>
            <a:ext cx="5041431" cy="1660450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D566DD63-7408-415A-ACA6-9D0A9728973E}"/>
              </a:ext>
            </a:extLst>
          </p:cNvPr>
          <p:cNvSpPr txBox="1"/>
          <p:nvPr/>
        </p:nvSpPr>
        <p:spPr>
          <a:xfrm>
            <a:off x="2993667" y="1372613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0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1F53A60A-3A3B-49CA-9295-37A472CBA58F}"/>
              </a:ext>
            </a:extLst>
          </p:cNvPr>
          <p:cNvSpPr txBox="1"/>
          <p:nvPr/>
        </p:nvSpPr>
        <p:spPr>
          <a:xfrm>
            <a:off x="2993667" y="1584524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84CC8C23-E3DE-450B-8C11-05B7495CBAA3}"/>
              </a:ext>
            </a:extLst>
          </p:cNvPr>
          <p:cNvSpPr txBox="1"/>
          <p:nvPr/>
        </p:nvSpPr>
        <p:spPr>
          <a:xfrm>
            <a:off x="3043632" y="1788924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383508A1-9C1F-469F-97DE-F32A64127816}"/>
              </a:ext>
            </a:extLst>
          </p:cNvPr>
          <p:cNvSpPr txBox="1"/>
          <p:nvPr/>
        </p:nvSpPr>
        <p:spPr>
          <a:xfrm>
            <a:off x="3021652" y="2087461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E93E4B19-ABF8-4935-B53F-79E92725D920}"/>
              </a:ext>
            </a:extLst>
          </p:cNvPr>
          <p:cNvSpPr txBox="1"/>
          <p:nvPr/>
        </p:nvSpPr>
        <p:spPr>
          <a:xfrm>
            <a:off x="3032941" y="2339926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B0E7D311-06C9-49F7-B767-AB37EE12B930}"/>
              </a:ext>
            </a:extLst>
          </p:cNvPr>
          <p:cNvSpPr txBox="1"/>
          <p:nvPr/>
        </p:nvSpPr>
        <p:spPr>
          <a:xfrm>
            <a:off x="2978346" y="658998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C02B8897-4BD9-41C8-8265-7E3E7328F992}"/>
              </a:ext>
            </a:extLst>
          </p:cNvPr>
          <p:cNvSpPr txBox="1"/>
          <p:nvPr/>
        </p:nvSpPr>
        <p:spPr>
          <a:xfrm>
            <a:off x="2337816" y="155946"/>
            <a:ext cx="4090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3A595A07-5DFE-4381-8F1E-5C7407911F5F}"/>
              </a:ext>
            </a:extLst>
          </p:cNvPr>
          <p:cNvSpPr txBox="1"/>
          <p:nvPr/>
        </p:nvSpPr>
        <p:spPr>
          <a:xfrm>
            <a:off x="2981183" y="1087949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0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D26B5EFB-D499-462A-B54B-1D428377A783}"/>
              </a:ext>
            </a:extLst>
          </p:cNvPr>
          <p:cNvSpPr txBox="1"/>
          <p:nvPr/>
        </p:nvSpPr>
        <p:spPr>
          <a:xfrm>
            <a:off x="4447823" y="520151"/>
            <a:ext cx="8899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</a:p>
        </p:txBody>
      </p: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9DAEE0BF-FCDA-4E07-A1A0-9A59392581D5}"/>
              </a:ext>
            </a:extLst>
          </p:cNvPr>
          <p:cNvCxnSpPr>
            <a:cxnSpLocks/>
          </p:cNvCxnSpPr>
          <p:nvPr/>
        </p:nvCxnSpPr>
        <p:spPr>
          <a:xfrm>
            <a:off x="4128398" y="941223"/>
            <a:ext cx="152883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D179B52B-E214-4440-8F5E-8F9ED3FAB422}"/>
              </a:ext>
            </a:extLst>
          </p:cNvPr>
          <p:cNvCxnSpPr>
            <a:cxnSpLocks/>
          </p:cNvCxnSpPr>
          <p:nvPr/>
        </p:nvCxnSpPr>
        <p:spPr>
          <a:xfrm>
            <a:off x="6000044" y="924290"/>
            <a:ext cx="152883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5C9D0BE2-26B4-4233-8844-402EDED277EF}"/>
              </a:ext>
            </a:extLst>
          </p:cNvPr>
          <p:cNvSpPr txBox="1"/>
          <p:nvPr/>
        </p:nvSpPr>
        <p:spPr>
          <a:xfrm>
            <a:off x="5851392" y="509195"/>
            <a:ext cx="18261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ibiotic-treated</a:t>
            </a: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CB8D8043-448F-4ED9-A083-1D895120361F}"/>
              </a:ext>
            </a:extLst>
          </p:cNvPr>
          <p:cNvSpPr/>
          <p:nvPr/>
        </p:nvSpPr>
        <p:spPr>
          <a:xfrm>
            <a:off x="4038085" y="1412157"/>
            <a:ext cx="3694803" cy="276999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8" name="Picture 37">
            <a:extLst>
              <a:ext uri="{FF2B5EF4-FFF2-40B4-BE49-F238E27FC236}">
                <a16:creationId xmlns:a16="http://schemas.microsoft.com/office/drawing/2014/main" id="{B4B83D14-5867-4604-8560-4ADAC16A279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6667" t="42290" r="39197" b="33498"/>
          <a:stretch/>
        </p:blipFill>
        <p:spPr>
          <a:xfrm>
            <a:off x="3413975" y="3209697"/>
            <a:ext cx="4842933" cy="1660449"/>
          </a:xfrm>
          <a:prstGeom prst="rect">
            <a:avLst/>
          </a:prstGeom>
        </p:spPr>
      </p:pic>
      <p:sp>
        <p:nvSpPr>
          <p:cNvPr id="39" name="TextBox 38">
            <a:extLst>
              <a:ext uri="{FF2B5EF4-FFF2-40B4-BE49-F238E27FC236}">
                <a16:creationId xmlns:a16="http://schemas.microsoft.com/office/drawing/2014/main" id="{A5F4BD2B-3C4B-4759-93FC-46A348AFABC8}"/>
              </a:ext>
            </a:extLst>
          </p:cNvPr>
          <p:cNvSpPr txBox="1"/>
          <p:nvPr/>
        </p:nvSpPr>
        <p:spPr>
          <a:xfrm>
            <a:off x="3089622" y="3557011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0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011FD32A-BBB1-4902-B869-70A82444F953}"/>
              </a:ext>
            </a:extLst>
          </p:cNvPr>
          <p:cNvSpPr txBox="1"/>
          <p:nvPr/>
        </p:nvSpPr>
        <p:spPr>
          <a:xfrm>
            <a:off x="3089622" y="3768922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EE801FA8-5CA5-459D-91CE-851AC59C47C6}"/>
              </a:ext>
            </a:extLst>
          </p:cNvPr>
          <p:cNvSpPr txBox="1"/>
          <p:nvPr/>
        </p:nvSpPr>
        <p:spPr>
          <a:xfrm>
            <a:off x="3139587" y="3973322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52ADAC81-1DA6-4C95-8779-72DCD11FDB5B}"/>
              </a:ext>
            </a:extLst>
          </p:cNvPr>
          <p:cNvSpPr txBox="1"/>
          <p:nvPr/>
        </p:nvSpPr>
        <p:spPr>
          <a:xfrm>
            <a:off x="3117607" y="4271859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13DDBBF4-94DA-471C-921E-2D3317EE5B2D}"/>
              </a:ext>
            </a:extLst>
          </p:cNvPr>
          <p:cNvSpPr txBox="1"/>
          <p:nvPr/>
        </p:nvSpPr>
        <p:spPr>
          <a:xfrm>
            <a:off x="3128896" y="4524324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CAA3BDE2-DE2F-4522-9EF0-848CBB71B920}"/>
              </a:ext>
            </a:extLst>
          </p:cNvPr>
          <p:cNvSpPr txBox="1"/>
          <p:nvPr/>
        </p:nvSpPr>
        <p:spPr>
          <a:xfrm>
            <a:off x="2364096" y="2840365"/>
            <a:ext cx="4090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FDB82F16-CD66-4C98-9E80-2D83C1D8EC87}"/>
              </a:ext>
            </a:extLst>
          </p:cNvPr>
          <p:cNvSpPr txBox="1"/>
          <p:nvPr/>
        </p:nvSpPr>
        <p:spPr>
          <a:xfrm>
            <a:off x="3077138" y="3272347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0</a:t>
            </a:r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9D476E02-63C4-44FD-8AA5-122F6638A6A3}"/>
              </a:ext>
            </a:extLst>
          </p:cNvPr>
          <p:cNvSpPr/>
          <p:nvPr/>
        </p:nvSpPr>
        <p:spPr>
          <a:xfrm>
            <a:off x="3964705" y="3630426"/>
            <a:ext cx="3694803" cy="276999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77219FB2-48FE-40A4-A4CE-93D6CAA71591}"/>
              </a:ext>
            </a:extLst>
          </p:cNvPr>
          <p:cNvSpPr txBox="1"/>
          <p:nvPr/>
        </p:nvSpPr>
        <p:spPr>
          <a:xfrm>
            <a:off x="4419599" y="2727133"/>
            <a:ext cx="8899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</a:p>
        </p:txBody>
      </p: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291C1422-CC11-4BEB-A944-F57F6B9095C4}"/>
              </a:ext>
            </a:extLst>
          </p:cNvPr>
          <p:cNvCxnSpPr>
            <a:cxnSpLocks/>
          </p:cNvCxnSpPr>
          <p:nvPr/>
        </p:nvCxnSpPr>
        <p:spPr>
          <a:xfrm>
            <a:off x="4100174" y="3136916"/>
            <a:ext cx="152883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B36D1A0C-3A37-4C73-A0AF-8CDDD60A129F}"/>
              </a:ext>
            </a:extLst>
          </p:cNvPr>
          <p:cNvCxnSpPr>
            <a:cxnSpLocks/>
          </p:cNvCxnSpPr>
          <p:nvPr/>
        </p:nvCxnSpPr>
        <p:spPr>
          <a:xfrm>
            <a:off x="5971820" y="3119983"/>
            <a:ext cx="152883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49">
            <a:extLst>
              <a:ext uri="{FF2B5EF4-FFF2-40B4-BE49-F238E27FC236}">
                <a16:creationId xmlns:a16="http://schemas.microsoft.com/office/drawing/2014/main" id="{759FA683-78E3-48D3-B0EE-2FA204138039}"/>
              </a:ext>
            </a:extLst>
          </p:cNvPr>
          <p:cNvSpPr txBox="1"/>
          <p:nvPr/>
        </p:nvSpPr>
        <p:spPr>
          <a:xfrm>
            <a:off x="5823168" y="2716177"/>
            <a:ext cx="18261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ibiotic-treated</a:t>
            </a:r>
          </a:p>
        </p:txBody>
      </p:sp>
    </p:spTree>
    <p:extLst>
      <p:ext uri="{BB962C8B-B14F-4D97-AF65-F5344CB8AC3E}">
        <p14:creationId xmlns:p14="http://schemas.microsoft.com/office/powerpoint/2010/main" val="27695442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7</TotalTime>
  <Words>69</Words>
  <Application>Microsoft Office PowerPoint</Application>
  <PresentationFormat>Widescreen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lke Sokoya</dc:creator>
  <cp:lastModifiedBy>Elke Sokoya</cp:lastModifiedBy>
  <cp:revision>20</cp:revision>
  <dcterms:created xsi:type="dcterms:W3CDTF">2021-07-12T05:07:12Z</dcterms:created>
  <dcterms:modified xsi:type="dcterms:W3CDTF">2021-10-13T05:35:53Z</dcterms:modified>
</cp:coreProperties>
</file>